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</p:sldIdLst>
  <p:sldSz cx="9144000" cy="6858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2" autoAdjust="0"/>
    <p:restoredTop sz="94660"/>
  </p:normalViewPr>
  <p:slideViewPr>
    <p:cSldViewPr snapToGrid="0" showGuides="1">
      <p:cViewPr varScale="1">
        <p:scale>
          <a:sx n="126" d="100"/>
          <a:sy n="126" d="100"/>
        </p:scale>
        <p:origin x="864" y="13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7BCAD-DE4D-4A6C-A582-02DEF7AA21EB}" type="datetimeFigureOut">
              <a:rPr lang="en-US" smtClean="0"/>
              <a:t>9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F19F7-C9DB-482D-95A1-3DAC15A86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74363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7BCAD-DE4D-4A6C-A582-02DEF7AA21EB}" type="datetimeFigureOut">
              <a:rPr lang="en-US" smtClean="0"/>
              <a:t>9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F19F7-C9DB-482D-95A1-3DAC15A86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18132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7BCAD-DE4D-4A6C-A582-02DEF7AA21EB}" type="datetimeFigureOut">
              <a:rPr lang="en-US" smtClean="0"/>
              <a:t>9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F19F7-C9DB-482D-95A1-3DAC15A86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39094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7BCAD-DE4D-4A6C-A582-02DEF7AA21EB}" type="datetimeFigureOut">
              <a:rPr lang="en-US" smtClean="0"/>
              <a:t>9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F19F7-C9DB-482D-95A1-3DAC15A86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65206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7BCAD-DE4D-4A6C-A582-02DEF7AA21EB}" type="datetimeFigureOut">
              <a:rPr lang="en-US" smtClean="0"/>
              <a:t>9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F19F7-C9DB-482D-95A1-3DAC15A86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33641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7BCAD-DE4D-4A6C-A582-02DEF7AA21EB}" type="datetimeFigureOut">
              <a:rPr lang="en-US" smtClean="0"/>
              <a:t>9/1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F19F7-C9DB-482D-95A1-3DAC15A86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95477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7BCAD-DE4D-4A6C-A582-02DEF7AA21EB}" type="datetimeFigureOut">
              <a:rPr lang="en-US" smtClean="0"/>
              <a:t>9/17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F19F7-C9DB-482D-95A1-3DAC15A86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2728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7BCAD-DE4D-4A6C-A582-02DEF7AA21EB}" type="datetimeFigureOut">
              <a:rPr lang="en-US" smtClean="0"/>
              <a:t>9/17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F19F7-C9DB-482D-95A1-3DAC15A86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90382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7BCAD-DE4D-4A6C-A582-02DEF7AA21EB}" type="datetimeFigureOut">
              <a:rPr lang="en-US" smtClean="0"/>
              <a:t>9/17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F19F7-C9DB-482D-95A1-3DAC15A86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4258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7BCAD-DE4D-4A6C-A582-02DEF7AA21EB}" type="datetimeFigureOut">
              <a:rPr lang="en-US" smtClean="0"/>
              <a:t>9/1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F19F7-C9DB-482D-95A1-3DAC15A86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58452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7BCAD-DE4D-4A6C-A582-02DEF7AA21EB}" type="datetimeFigureOut">
              <a:rPr lang="en-US" smtClean="0"/>
              <a:t>9/1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F19F7-C9DB-482D-95A1-3DAC15A86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83302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67BCAD-DE4D-4A6C-A582-02DEF7AA21EB}" type="datetimeFigureOut">
              <a:rPr lang="en-US" smtClean="0"/>
              <a:t>9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CF19F7-C9DB-482D-95A1-3DAC15A86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33556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5"/>
          <p:cNvSpPr>
            <a:spLocks noChangeArrowheads="1"/>
          </p:cNvSpPr>
          <p:nvPr/>
        </p:nvSpPr>
        <p:spPr bwMode="auto">
          <a:xfrm>
            <a:off x="2935708" y="2066288"/>
            <a:ext cx="138564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68580" tIns="34290" rIns="68580" bIns="3429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 sz="1350"/>
          </a:p>
        </p:txBody>
      </p:sp>
      <p:sp>
        <p:nvSpPr>
          <p:cNvPr id="4" name="Rectangle 3"/>
          <p:cNvSpPr/>
          <p:nvPr/>
        </p:nvSpPr>
        <p:spPr>
          <a:xfrm>
            <a:off x="349256" y="961337"/>
            <a:ext cx="871531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sz="1200" b="1">
                <a:solidFill>
                  <a:srgbClr val="000000"/>
                </a:solidFill>
                <a:latin typeface="Calibri" panose="020F0502020204030204" pitchFamily="34" charset="0"/>
              </a:rPr>
              <a:t>TABLE S3. </a:t>
            </a:r>
            <a:r>
              <a:rPr lang="en-US" sz="1200" dirty="0">
                <a:solidFill>
                  <a:srgbClr val="000000"/>
                </a:solidFill>
                <a:latin typeface="Calibri" panose="020F0502020204030204" pitchFamily="34" charset="0"/>
              </a:rPr>
              <a:t>Correlations between age and MFI values against recombinant </a:t>
            </a:r>
            <a:r>
              <a:rPr lang="en-US" sz="1200" dirty="0" err="1">
                <a:solidFill>
                  <a:srgbClr val="000000"/>
                </a:solidFill>
                <a:latin typeface="Calibri" panose="020F0502020204030204" pitchFamily="34" charset="0"/>
              </a:rPr>
              <a:t>ectodomain</a:t>
            </a:r>
            <a:r>
              <a:rPr lang="en-US" sz="1200" dirty="0">
                <a:solidFill>
                  <a:srgbClr val="000000"/>
                </a:solidFill>
                <a:latin typeface="Calibri" panose="020F0502020204030204" pitchFamily="34" charset="0"/>
              </a:rPr>
              <a:t> (</a:t>
            </a:r>
            <a:r>
              <a:rPr lang="en-US" sz="1200" dirty="0" err="1">
                <a:solidFill>
                  <a:srgbClr val="000000"/>
                </a:solidFill>
                <a:latin typeface="Calibri" panose="020F0502020204030204" pitchFamily="34" charset="0"/>
              </a:rPr>
              <a:t>Ecto</a:t>
            </a:r>
            <a:r>
              <a:rPr lang="en-US" sz="1200" dirty="0">
                <a:solidFill>
                  <a:srgbClr val="000000"/>
                </a:solidFill>
                <a:latin typeface="Calibri" panose="020F0502020204030204" pitchFamily="34" charset="0"/>
              </a:rPr>
              <a:t>) and/or globular head domain HA1 (GH HA1)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93A72-EB5E-4516-8B68-127BE3EAE9A6}" type="slidenum">
              <a:rPr lang="en-US" smtClean="0"/>
              <a:t>1</a:t>
            </a:fld>
            <a:endParaRPr lang="en-US"/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21053006"/>
              </p:ext>
            </p:extLst>
          </p:nvPr>
        </p:nvGraphicFramePr>
        <p:xfrm>
          <a:off x="542088" y="1238336"/>
          <a:ext cx="7813125" cy="4502896"/>
        </p:xfrm>
        <a:graphic>
          <a:graphicData uri="http://schemas.openxmlformats.org/drawingml/2006/table">
            <a:tbl>
              <a:tblPr/>
              <a:tblGrid>
                <a:gridCol w="388834">
                  <a:extLst>
                    <a:ext uri="{9D8B030D-6E8A-4147-A177-3AD203B41FA5}">
                      <a16:colId xmlns:a16="http://schemas.microsoft.com/office/drawing/2014/main" val="3159622934"/>
                    </a:ext>
                  </a:extLst>
                </a:gridCol>
                <a:gridCol w="1063217">
                  <a:extLst>
                    <a:ext uri="{9D8B030D-6E8A-4147-A177-3AD203B41FA5}">
                      <a16:colId xmlns:a16="http://schemas.microsoft.com/office/drawing/2014/main" val="3966016270"/>
                    </a:ext>
                  </a:extLst>
                </a:gridCol>
                <a:gridCol w="2083905">
                  <a:extLst>
                    <a:ext uri="{9D8B030D-6E8A-4147-A177-3AD203B41FA5}">
                      <a16:colId xmlns:a16="http://schemas.microsoft.com/office/drawing/2014/main" val="2586265750"/>
                    </a:ext>
                  </a:extLst>
                </a:gridCol>
                <a:gridCol w="164039">
                  <a:extLst>
                    <a:ext uri="{9D8B030D-6E8A-4147-A177-3AD203B41FA5}">
                      <a16:colId xmlns:a16="http://schemas.microsoft.com/office/drawing/2014/main" val="919000006"/>
                    </a:ext>
                  </a:extLst>
                </a:gridCol>
                <a:gridCol w="1865186">
                  <a:extLst>
                    <a:ext uri="{9D8B030D-6E8A-4147-A177-3AD203B41FA5}">
                      <a16:colId xmlns:a16="http://schemas.microsoft.com/office/drawing/2014/main" val="1411393207"/>
                    </a:ext>
                  </a:extLst>
                </a:gridCol>
                <a:gridCol w="164039">
                  <a:extLst>
                    <a:ext uri="{9D8B030D-6E8A-4147-A177-3AD203B41FA5}">
                      <a16:colId xmlns:a16="http://schemas.microsoft.com/office/drawing/2014/main" val="3843907459"/>
                    </a:ext>
                  </a:extLst>
                </a:gridCol>
                <a:gridCol w="2083905">
                  <a:extLst>
                    <a:ext uri="{9D8B030D-6E8A-4147-A177-3AD203B41FA5}">
                      <a16:colId xmlns:a16="http://schemas.microsoft.com/office/drawing/2014/main" val="4233747210"/>
                    </a:ext>
                  </a:extLst>
                </a:gridCol>
              </a:tblGrid>
              <a:tr h="164295">
                <a:tc gridSpan="7">
                  <a:txBody>
                    <a:bodyPr/>
                    <a:lstStyle/>
                    <a:p>
                      <a:pPr algn="l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07413731"/>
                  </a:ext>
                </a:extLst>
              </a:tr>
              <a:tr h="164295">
                <a:tc>
                  <a:txBody>
                    <a:bodyPr/>
                    <a:lstStyle/>
                    <a:p>
                      <a:pPr algn="l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42026961"/>
                  </a:ext>
                </a:extLst>
              </a:tr>
              <a:tr h="16429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#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de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HS (n=133)</a:t>
                      </a:r>
                      <a:r>
                        <a:rPr lang="en-US" sz="9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Y (n=119)</a:t>
                      </a:r>
                      <a:r>
                        <a:rPr lang="en-US" sz="9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D (n=29)</a:t>
                      </a:r>
                      <a:r>
                        <a:rPr lang="en-US" sz="9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36989746"/>
                  </a:ext>
                </a:extLst>
              </a:tr>
              <a:tr h="16429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1.Mar.43 Ecto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80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55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22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53530363"/>
                  </a:ext>
                </a:extLst>
              </a:tr>
              <a:tr h="16429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1.Tx.91 Ecto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301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168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124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77151549"/>
                  </a:ext>
                </a:extLst>
              </a:tr>
              <a:tr h="16429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1.CA.09 Ecto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4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37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192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84152123"/>
                  </a:ext>
                </a:extLst>
              </a:tr>
              <a:tr h="16429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1.CA.09 GH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192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102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249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41596914"/>
                  </a:ext>
                </a:extLst>
              </a:tr>
              <a:tr h="16429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2.Jap.57 GH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99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17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17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892498"/>
                  </a:ext>
                </a:extLst>
              </a:tr>
              <a:tr h="16429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3.HK.68 Ecto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66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86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09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881473"/>
                  </a:ext>
                </a:extLst>
              </a:tr>
              <a:tr h="16429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3.LND.86 Ecto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316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113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85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81915581"/>
                  </a:ext>
                </a:extLst>
              </a:tr>
              <a:tr h="16429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3.Per.09 Ecto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207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116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28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77185192"/>
                  </a:ext>
                </a:extLst>
              </a:tr>
              <a:tr h="16429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3.Per.09 GH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207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113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08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27595391"/>
                  </a:ext>
                </a:extLst>
              </a:tr>
              <a:tr h="16429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5.VN.04 GH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84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58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411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67915645"/>
                  </a:ext>
                </a:extLst>
              </a:tr>
              <a:tr h="16429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5.Ind.05 Ecto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74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21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400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04163477"/>
                  </a:ext>
                </a:extLst>
              </a:tr>
              <a:tr h="16429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5.Ind.05 GH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45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66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500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07536154"/>
                  </a:ext>
                </a:extLst>
              </a:tr>
              <a:tr h="16429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7.NED. 03 GH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6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3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14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39967816"/>
                  </a:ext>
                </a:extLst>
              </a:tr>
              <a:tr h="16429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7.SH. 13 GH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35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30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87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2439289"/>
                  </a:ext>
                </a:extLst>
              </a:tr>
              <a:tr h="16429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7.NY. 16 Ecto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05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362</a:t>
                      </a:r>
                      <a:r>
                        <a:rPr lang="en-US" sz="9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2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2883199"/>
                  </a:ext>
                </a:extLst>
              </a:tr>
              <a:tr h="16429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9.HK.09 GH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37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09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57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09537789"/>
                  </a:ext>
                </a:extLst>
              </a:tr>
              <a:tr h="16429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13.DE.04 GH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77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03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120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66102611"/>
                  </a:ext>
                </a:extLst>
              </a:tr>
              <a:tr h="16429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.Bris.08 GH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41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77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95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56646468"/>
                  </a:ext>
                </a:extLst>
              </a:tr>
              <a:tr h="16429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.Wis.10 GH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195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285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179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45856038"/>
                  </a:ext>
                </a:extLst>
              </a:tr>
              <a:tr h="16429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tein A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278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29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276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15300065"/>
                  </a:ext>
                </a:extLst>
              </a:tr>
              <a:tr h="164295">
                <a:tc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84129224"/>
                  </a:ext>
                </a:extLst>
              </a:tr>
              <a:tr h="139954">
                <a:tc gridSpan="7"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baseline="300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  <a:r>
                        <a:rPr lang="en-US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arson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en-U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values between ages of age-matched unexposed persons in the States of New York and Florida and MFI values against recombinant </a:t>
                      </a:r>
                      <a:r>
                        <a:rPr lang="en-US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ctodomain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(</a:t>
                      </a:r>
                      <a:r>
                        <a:rPr lang="en-US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cto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 and/or globular head domain HA1 (GH HA1)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1200681"/>
                  </a:ext>
                </a:extLst>
              </a:tr>
              <a:tr h="139954">
                <a:tc gridSpan="7"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baseline="300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  <a:r>
                        <a:rPr lang="en-US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arson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en-U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values between ages of exposed persons in New York H7N2 study and MFI values against recombinant </a:t>
                      </a:r>
                      <a:r>
                        <a:rPr lang="en-US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ctodomain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(</a:t>
                      </a:r>
                      <a:r>
                        <a:rPr lang="en-US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cto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 and/or globular head domain HA1 (GH HA1)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98288432"/>
                  </a:ext>
                </a:extLst>
              </a:tr>
              <a:tr h="139954">
                <a:tc gridSpan="7"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baseline="300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</a:t>
                      </a:r>
                      <a:r>
                        <a:rPr lang="en-US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arson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en-U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values between ages of live poultry market workers in Bangladesh and MFI values against recombinant </a:t>
                      </a:r>
                      <a:r>
                        <a:rPr lang="en-US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ctodomain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(</a:t>
                      </a:r>
                      <a:r>
                        <a:rPr lang="en-US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cto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 and/or globular head domain HA1 (GH HA1)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89019235"/>
                  </a:ext>
                </a:extLst>
              </a:tr>
              <a:tr h="139954"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baseline="300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  <a:r>
                        <a:rPr lang="en-US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gative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Pearson </a:t>
                      </a:r>
                      <a:r>
                        <a:rPr lang="en-U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values between ages and potential exposed HA subtypes were shown in bold</a:t>
                      </a: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5" marR="6085" marT="60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763892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9644302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69</TotalTime>
  <Words>396</Words>
  <Application>Microsoft Office PowerPoint</Application>
  <PresentationFormat>On-screen Show (4:3)</PresentationFormat>
  <Paragraphs>1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Centers for Disease Control and Preventi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, Zhunan (CDC/DDID/NCIRD/ID)</dc:creator>
  <cp:lastModifiedBy>Li, Zhunan (CDC/DDID/NCIRD/ID)</cp:lastModifiedBy>
  <cp:revision>28</cp:revision>
  <cp:lastPrinted>2019-03-12T18:58:54Z</cp:lastPrinted>
  <dcterms:created xsi:type="dcterms:W3CDTF">2018-12-18T19:55:04Z</dcterms:created>
  <dcterms:modified xsi:type="dcterms:W3CDTF">2019-09-17T19:44:42Z</dcterms:modified>
</cp:coreProperties>
</file>